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4" d="100"/>
          <a:sy n="64" d="100"/>
        </p:scale>
        <p:origin x="600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17CE6C-345B-A7C2-ACD0-DEBA4AC4EF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836732-7D5B-3A7E-068E-ED25BD0386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A825ED-DC44-3807-677D-FD93FDF98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59C008-1339-971B-BFAC-A90D1B859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7736E7-BDA7-0DE1-91BD-6581AD11F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758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D811A-0923-EA68-8D16-174A638A2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64A36A-287E-EC6C-C462-B24FF4B14F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9340B7-E81D-4187-DE06-C2B5F4023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06123A-FFCA-DFA9-AD69-9D7277B51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451B86-96EE-326C-6D66-C23BE6A6D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8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24407A-05FD-FECE-6887-E1971739DF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73203A-E119-39B5-4AB7-91299304AC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7D9CA1-5740-00B6-9BE1-15F8D52EF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DE91A-7FF1-D029-5FBC-97ACC8DD2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5011FE-A5A4-B5F7-76BF-C10223B28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503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1F86F-A16E-D288-65DD-3387DE8ED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D2A49F-CB77-FCF2-D2C7-BB915AB0C8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0996A2-7326-26EF-A03C-82C09BE88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583CD9-9D7A-155D-B375-C971EA85A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CCA256-59CF-8887-7BB6-AA036B352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75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F65A1-A75D-3EE6-CE9F-419EF0422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7CDB99-7B66-BE63-5F6F-1CE6C5645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BC5C9A-BD7D-E951-024D-D614C6088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2F34-7B8D-A283-87C0-513D6020C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AFFD47-C1A0-D760-1087-B230DE87D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118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BA81A-FE35-E34B-F571-98662CB71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1F721B-8718-B494-29EC-8502205C0D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E3D0F0-0490-EF82-CD50-316E77398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70D9DA-8C8B-0A7D-3FA6-7CE6E162B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F7EE28-8F64-2600-531E-4276FA3D3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61766E-7173-A5DB-F3BA-B24C8B9E3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95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04B6B1-8E28-8D7A-FA0A-794F6BD56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216E0C-C943-0503-9584-30C7BFD537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B06D61-1E14-F745-4BF7-9C25BDBC81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12610D-AEE2-1950-B945-D2D06537D3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200794-D296-F427-AC4F-AD513A85C4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375126-5D5A-7CBE-ECB2-07C5FCC85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D1BBA5-8B9C-4F8A-F35B-0AD99B528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03E94C-1EC0-9EEB-728A-6972CC3AE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241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8C4C7-CE3C-A139-4DC0-148265D4C2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84F71D-8149-0703-7BC8-36B25EDA9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82957B-7CD6-1F65-DC8C-3F61223A2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412DE-8890-AFF3-8C3B-00CBEA623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92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0EC579-3EEA-7832-A22C-64380D1C7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5F9456-A4A4-2ABC-EA40-3441F782E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03EDDF-2FD5-BED3-EB30-3B2F143F9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61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EB759-7E35-ADE3-A520-3FE09BD3A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EBB8DA-E38B-55C8-F50F-E8B88C987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5744C3-A86D-9282-1634-51682617D7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D5BBD3-A528-505A-672E-C3D22BD3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1A8644-B70F-DDB8-EEC5-A2FF761BE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053C74-11EE-9B4D-24FA-D7C29E76C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123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326714-9231-32D0-3943-64D26263A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72F35E-3638-E877-9D7A-62C48E07B2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3CC662-E16A-1919-6BBB-C861B7AF82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5D5478-92A1-E599-B46B-AC766325C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8CDA15-3998-4309-EF17-93B7A7C54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97623C-9F49-C1DE-45D7-B43117111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68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D0F97E-3FE3-CBEA-E98B-8A1965F1D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159061-D7D3-FE9B-58E9-341CFBB195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74EC84-185A-AAB7-72CD-680012FAB3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CCC35-EB0B-4C72-B378-06CEE3923A66}" type="datetimeFigureOut">
              <a:rPr lang="en-US" smtClean="0"/>
              <a:t>5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CBD2DE-06B7-9647-2137-1FDDAD0D8E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2D6D8D-A295-849A-3B20-60871F4268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CAFE3-409B-4E21-9F84-8D764F18F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077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wmv"/><Relationship Id="rId7" Type="http://schemas.openxmlformats.org/officeDocument/2006/relationships/image" Target="../media/image2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wm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E817BD-F1C7-D431-887F-0C37F1A93E9C}"/>
              </a:ext>
            </a:extLst>
          </p:cNvPr>
          <p:cNvSpPr txBox="1"/>
          <p:nvPr/>
        </p:nvSpPr>
        <p:spPr>
          <a:xfrm>
            <a:off x="441659" y="5253344"/>
            <a:ext cx="1124544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ry video: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4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Trained PBMCs generate potent cytotoxic activity via co-culture with irradiated BET/JQ1/C170 treated tumor cells, assessed by live-cell imaging.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4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IncuCyte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Live-Cell Analysis System was used to assess T cell cytotoxicity. PBMCs were trained with irradiated untreated HNB cells, HNB cells treated with 0.25µM BET/JQ1, or with 1.5 µM C-170 and 0.25 µM BET/JQ1 for 7 days. Subsequently, HNB cancer cells were co-cultured with untrained PBMCs </a:t>
            </a:r>
            <a:r>
              <a:rPr lang="en-US" sz="14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(A)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or trained PBMCs </a:t>
            </a:r>
            <a:r>
              <a:rPr lang="en-US" sz="14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(B) 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at a ratio of 1:30 in 96-well plates. HNB tumor cells were stained with </a:t>
            </a:r>
            <a:r>
              <a:rPr lang="en-US" sz="14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CytoLight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Red dye, and apoptotic cells are marked by Caspase 3/7 Green. The yellow color indicates apoptotic tumor cells undergoing cytotoxicity. Representative time-lapse images captured by the </a:t>
            </a:r>
            <a:r>
              <a:rPr lang="en-US" sz="14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IncuCyte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system showing target cell lysis by cytotoxic T cells over a period of 24 hours. </a:t>
            </a:r>
            <a:endParaRPr lang="en-US" sz="1400" dirty="0"/>
          </a:p>
        </p:txBody>
      </p:sp>
      <p:pic>
        <p:nvPicPr>
          <p:cNvPr id="5" name="PBMC CNH5_G2_2">
            <a:hlinkClick r:id="" action="ppaction://media"/>
            <a:extLst>
              <a:ext uri="{FF2B5EF4-FFF2-40B4-BE49-F238E27FC236}">
                <a16:creationId xmlns:a16="http://schemas.microsoft.com/office/drawing/2014/main" id="{1B8CF52D-AFF2-9A77-E5C5-1C7EAD09100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41659" y="752487"/>
            <a:ext cx="5518875" cy="43477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240277-B693-F42C-C057-B78786AC92C2}"/>
              </a:ext>
            </a:extLst>
          </p:cNvPr>
          <p:cNvSpPr txBox="1"/>
          <p:nvPr/>
        </p:nvSpPr>
        <p:spPr>
          <a:xfrm>
            <a:off x="2218958" y="222682"/>
            <a:ext cx="2488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HNB+untrained</a:t>
            </a:r>
            <a:r>
              <a:rPr lang="en-US" dirty="0"/>
              <a:t> PBMCs</a:t>
            </a:r>
          </a:p>
        </p:txBody>
      </p:sp>
      <p:pic>
        <p:nvPicPr>
          <p:cNvPr id="9" name="C170 CNH5_E3_2">
            <a:hlinkClick r:id="" action="ppaction://media"/>
            <a:extLst>
              <a:ext uri="{FF2B5EF4-FFF2-40B4-BE49-F238E27FC236}">
                <a16:creationId xmlns:a16="http://schemas.microsoft.com/office/drawing/2014/main" id="{09BF8C7F-A1FB-4B14-122D-7C5756327F7B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168232" y="752487"/>
            <a:ext cx="5518874" cy="434771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95FA1F7-07A8-ECA1-F445-590BA1301DAF}"/>
              </a:ext>
            </a:extLst>
          </p:cNvPr>
          <p:cNvSpPr txBox="1"/>
          <p:nvPr/>
        </p:nvSpPr>
        <p:spPr>
          <a:xfrm>
            <a:off x="6449522" y="175761"/>
            <a:ext cx="5237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NB+TATs-T trained with C-170/BET/JQ1 treated HN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33DE62F-3F45-04BA-8851-6502C5871BEB}"/>
              </a:ext>
            </a:extLst>
          </p:cNvPr>
          <p:cNvSpPr txBox="1"/>
          <p:nvPr/>
        </p:nvSpPr>
        <p:spPr>
          <a:xfrm>
            <a:off x="228600" y="222682"/>
            <a:ext cx="536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19F0ECD-4051-4C79-8AEA-38EF10A1648A}"/>
              </a:ext>
            </a:extLst>
          </p:cNvPr>
          <p:cNvSpPr txBox="1"/>
          <p:nvPr/>
        </p:nvSpPr>
        <p:spPr>
          <a:xfrm>
            <a:off x="5899875" y="230016"/>
            <a:ext cx="536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986676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71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714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71</Words>
  <Application>Microsoft Office PowerPoint</Application>
  <PresentationFormat>Widescreen</PresentationFormat>
  <Paragraphs>5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Xiaofang</dc:creator>
  <cp:lastModifiedBy>Wu, Xiaofang</cp:lastModifiedBy>
  <cp:revision>5</cp:revision>
  <dcterms:created xsi:type="dcterms:W3CDTF">2024-05-01T19:41:20Z</dcterms:created>
  <dcterms:modified xsi:type="dcterms:W3CDTF">2025-05-27T15:57:53Z</dcterms:modified>
</cp:coreProperties>
</file>